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404" r:id="rId2"/>
    <p:sldId id="403" r:id="rId3"/>
    <p:sldId id="402" r:id="rId4"/>
  </p:sldIdLst>
  <p:sldSz cx="12192000" cy="6858000"/>
  <p:notesSz cx="6794500" cy="9931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765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965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FFFF00"/>
    <a:srgbClr val="0000FF"/>
    <a:srgbClr val="FFCC00"/>
    <a:srgbClr val="BB03B0"/>
    <a:srgbClr val="CC0099"/>
    <a:srgbClr val="66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9629" autoAdjust="0"/>
  </p:normalViewPr>
  <p:slideViewPr>
    <p:cSldViewPr>
      <p:cViewPr varScale="1">
        <p:scale>
          <a:sx n="83" d="100"/>
          <a:sy n="83" d="100"/>
        </p:scale>
        <p:origin x="643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29A402-2D81-4609-8BB5-E599A61C0952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32925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48100" y="9432925"/>
            <a:ext cx="294481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F8695-1CE2-484F-99BF-3560DCADC6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07F38E-F575-4CCD-A7BD-5C326A60D4BC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19100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2E2986-9F19-4945-8D93-04EACFF0A81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765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965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9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199765" indent="0" algn="ctr">
              <a:buNone/>
              <a:defRPr sz="1600"/>
            </a:lvl8pPr>
            <a:lvl9pPr marL="3656965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997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69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199765" indent="0">
              <a:buNone/>
              <a:defRPr sz="1600" b="1"/>
            </a:lvl8pPr>
            <a:lvl9pPr marL="3656965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199765" indent="0">
              <a:buNone/>
              <a:defRPr sz="1600" b="1"/>
            </a:lvl8pPr>
            <a:lvl9pPr marL="3656965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199765" indent="0">
              <a:buNone/>
              <a:defRPr sz="1000"/>
            </a:lvl8pPr>
            <a:lvl9pPr marL="3656965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199765" indent="0">
              <a:buNone/>
              <a:defRPr sz="2000"/>
            </a:lvl8pPr>
            <a:lvl9pPr marL="3656965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199765" indent="0">
              <a:buNone/>
              <a:defRPr sz="1000"/>
            </a:lvl8pPr>
            <a:lvl9pPr marL="3656965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1" y="365126"/>
            <a:ext cx="10515600" cy="1325563"/>
          </a:xfrm>
          <a:prstGeom prst="rect">
            <a:avLst/>
          </a:prstGeom>
        </p:spPr>
        <p:txBody>
          <a:bodyPr vert="horz" lIns="91430" tIns="45714" rIns="91430" bIns="45714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30" tIns="45714" rIns="91430" bIns="45714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1" y="6356350"/>
            <a:ext cx="27432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88D4E-4F42-4A1C-9CAC-0FCD3A58D984}" type="datetimeFigureOut">
              <a:rPr lang="zh-CN" altLang="en-US" smtClean="0"/>
              <a:t>2024/1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0D921-5CC4-4A5E-8413-41710A797F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6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6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56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6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96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/>
          <p:cNvSpPr txBox="1"/>
          <p:nvPr/>
        </p:nvSpPr>
        <p:spPr>
          <a:xfrm>
            <a:off x="1460704" y="4181475"/>
            <a:ext cx="79164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variation of banana plants’ disease severity level  treated by Se after being inoculated with </a:t>
            </a:r>
            <a:r>
              <a:rPr lang="en-US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4  in greenhouse experiments</a:t>
            </a: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70" y="954750"/>
            <a:ext cx="10668906" cy="2880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69428" y="5404395"/>
            <a:ext cx="7916400" cy="1061817"/>
          </a:xfrm>
          <a:prstGeom prst="rect">
            <a:avLst/>
          </a:prstGeom>
          <a:noFill/>
        </p:spPr>
        <p:txBody>
          <a:bodyPr wrap="square" lIns="91430" tIns="45714" rIns="91430" bIns="45714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Severe occurrence and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ste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ptoms of </a:t>
            </a:r>
            <a:r>
              <a:rPr lang="en-US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4 disease during the fruiting period in the field</a:t>
            </a:r>
          </a:p>
          <a:p>
            <a:pPr marL="228600" indent="-228600">
              <a:lnSpc>
                <a:spcPct val="150000"/>
              </a:lnSpc>
              <a:buAutoNum type="alphaUcParenBoth"/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boveground </a:t>
            </a:r>
            <a:r>
              <a:rPr lang="en-US" altLang="zh-CN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4 symptoms in banana plants in the field; Transversal section (B) and longitudinal section (C) of </a:t>
            </a:r>
            <a:r>
              <a:rPr lang="en-US" altLang="zh-CN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4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stem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ptoms in banana plant in field.  </a:t>
            </a:r>
          </a:p>
          <a:p>
            <a:pPr marL="228600" indent="-228600">
              <a:lnSpc>
                <a:spcPct val="150000"/>
              </a:lnSpc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The severe outbreak symptoms of banana wilt disease and suckers emerging in the diseased field in Fig. S3A.</a:t>
            </a:r>
          </a:p>
        </p:txBody>
      </p:sp>
      <p:grpSp>
        <p:nvGrpSpPr>
          <p:cNvPr id="10" name="组合 9"/>
          <p:cNvGrpSpPr/>
          <p:nvPr/>
        </p:nvGrpSpPr>
        <p:grpSpPr>
          <a:xfrm>
            <a:off x="1627580" y="625108"/>
            <a:ext cx="7099853" cy="4564799"/>
            <a:chOff x="1627580" y="625108"/>
            <a:chExt cx="7099853" cy="4564799"/>
          </a:xfrm>
        </p:grpSpPr>
        <p:grpSp>
          <p:nvGrpSpPr>
            <p:cNvPr id="4" name="组合 3"/>
            <p:cNvGrpSpPr/>
            <p:nvPr/>
          </p:nvGrpSpPr>
          <p:grpSpPr>
            <a:xfrm>
              <a:off x="1627580" y="625108"/>
              <a:ext cx="7099853" cy="4564799"/>
              <a:chOff x="1198955" y="573392"/>
              <a:chExt cx="7099853" cy="4564799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5238807" y="573393"/>
                <a:ext cx="3060000" cy="19865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 rot="16200000">
                <a:off x="5561276" y="2400660"/>
                <a:ext cx="2415063" cy="30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" name="图片 5" descr="IMG_5237.JPG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 rot="5400000">
                <a:off x="898829" y="1143992"/>
                <a:ext cx="4564799" cy="3423600"/>
              </a:xfrm>
              <a:prstGeom prst="rect">
                <a:avLst/>
              </a:prstGeom>
            </p:spPr>
          </p:pic>
          <p:sp>
            <p:nvSpPr>
              <p:cNvPr id="2" name="TextBox 58"/>
              <p:cNvSpPr txBox="1"/>
              <p:nvPr/>
            </p:nvSpPr>
            <p:spPr>
              <a:xfrm>
                <a:off x="1198955" y="573392"/>
                <a:ext cx="245372" cy="253904"/>
              </a:xfrm>
              <a:prstGeom prst="rect">
                <a:avLst/>
              </a:prstGeom>
              <a:noFill/>
            </p:spPr>
            <p:txBody>
              <a:bodyPr wrap="square" lIns="91430" tIns="45714" rIns="91430" bIns="45714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TextBox 58"/>
              <p:cNvSpPr txBox="1"/>
              <p:nvPr/>
            </p:nvSpPr>
            <p:spPr>
              <a:xfrm>
                <a:off x="4943232" y="573392"/>
                <a:ext cx="245372" cy="253904"/>
              </a:xfrm>
              <a:prstGeom prst="rect">
                <a:avLst/>
              </a:prstGeom>
              <a:noFill/>
            </p:spPr>
            <p:txBody>
              <a:bodyPr wrap="square" lIns="91430" tIns="45714" rIns="91430" bIns="45714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TextBox 58"/>
            <p:cNvSpPr txBox="1"/>
            <p:nvPr/>
          </p:nvSpPr>
          <p:spPr>
            <a:xfrm>
              <a:off x="5387097" y="2781568"/>
              <a:ext cx="245372" cy="253904"/>
            </a:xfrm>
            <a:prstGeom prst="rect">
              <a:avLst/>
            </a:prstGeom>
            <a:noFill/>
          </p:spPr>
          <p:txBody>
            <a:bodyPr wrap="square" lIns="91430" tIns="45714" rIns="91430" bIns="45714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580512" y="382492"/>
            <a:ext cx="10895489" cy="4206021"/>
            <a:chOff x="580512" y="382492"/>
            <a:chExt cx="10895489" cy="4206021"/>
          </a:xfrm>
        </p:grpSpPr>
        <p:grpSp>
          <p:nvGrpSpPr>
            <p:cNvPr id="3" name="组合 84"/>
            <p:cNvGrpSpPr/>
            <p:nvPr/>
          </p:nvGrpSpPr>
          <p:grpSpPr>
            <a:xfrm>
              <a:off x="580512" y="382492"/>
              <a:ext cx="10895489" cy="4206021"/>
              <a:chOff x="580512" y="382492"/>
              <a:chExt cx="10895489" cy="4206021"/>
            </a:xfrm>
          </p:grpSpPr>
          <p:grpSp>
            <p:nvGrpSpPr>
              <p:cNvPr id="4" name="组合 59"/>
              <p:cNvGrpSpPr/>
              <p:nvPr/>
            </p:nvGrpSpPr>
            <p:grpSpPr>
              <a:xfrm>
                <a:off x="893808" y="382492"/>
                <a:ext cx="10582193" cy="1435265"/>
                <a:chOff x="893808" y="1287267"/>
                <a:chExt cx="10582193" cy="1435265"/>
              </a:xfrm>
            </p:grpSpPr>
            <p:cxnSp>
              <p:nvCxnSpPr>
                <p:cNvPr id="5" name="直接连接符 4"/>
                <p:cNvCxnSpPr/>
                <p:nvPr/>
              </p:nvCxnSpPr>
              <p:spPr>
                <a:xfrm>
                  <a:off x="1065456" y="1980896"/>
                  <a:ext cx="2890528" cy="0"/>
                </a:xfrm>
                <a:prstGeom prst="line">
                  <a:avLst/>
                </a:prstGeom>
                <a:ln w="203200"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直接连接符 7"/>
                <p:cNvCxnSpPr/>
                <p:nvPr/>
              </p:nvCxnSpPr>
              <p:spPr>
                <a:xfrm>
                  <a:off x="3955984" y="1980896"/>
                  <a:ext cx="1463040" cy="0"/>
                </a:xfrm>
                <a:prstGeom prst="line">
                  <a:avLst/>
                </a:prstGeom>
                <a:ln w="203200">
                  <a:solidFill>
                    <a:schemeClr val="accent2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连接符 10"/>
                <p:cNvCxnSpPr/>
                <p:nvPr/>
              </p:nvCxnSpPr>
              <p:spPr>
                <a:xfrm>
                  <a:off x="5393624" y="1980896"/>
                  <a:ext cx="5736656" cy="0"/>
                </a:xfrm>
                <a:prstGeom prst="line">
                  <a:avLst/>
                </a:prstGeom>
                <a:ln w="203200">
                  <a:solidFill>
                    <a:schemeClr val="accent4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箭头连接符 24"/>
                <p:cNvCxnSpPr/>
                <p:nvPr/>
              </p:nvCxnSpPr>
              <p:spPr>
                <a:xfrm flipV="1">
                  <a:off x="3936734" y="2088682"/>
                  <a:ext cx="0" cy="288758"/>
                </a:xfrm>
                <a:prstGeom prst="straightConnector1">
                  <a:avLst/>
                </a:prstGeom>
                <a:ln w="508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箭头连接符 27"/>
                <p:cNvCxnSpPr/>
                <p:nvPr/>
              </p:nvCxnSpPr>
              <p:spPr>
                <a:xfrm flipV="1">
                  <a:off x="11155680" y="2088682"/>
                  <a:ext cx="0" cy="288758"/>
                </a:xfrm>
                <a:prstGeom prst="straightConnector1">
                  <a:avLst/>
                </a:prstGeom>
                <a:ln w="508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箭头连接符 28"/>
                <p:cNvCxnSpPr/>
                <p:nvPr/>
              </p:nvCxnSpPr>
              <p:spPr>
                <a:xfrm flipV="1">
                  <a:off x="1065456" y="2088682"/>
                  <a:ext cx="0" cy="288758"/>
                </a:xfrm>
                <a:prstGeom prst="straightConnector1">
                  <a:avLst/>
                </a:prstGeom>
                <a:ln w="508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文本框 29"/>
                <p:cNvSpPr txBox="1"/>
                <p:nvPr/>
              </p:nvSpPr>
              <p:spPr>
                <a:xfrm>
                  <a:off x="893808" y="2353200"/>
                  <a:ext cx="158149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e Treatments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3054683" y="2353200"/>
                  <a:ext cx="17451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4 Inoculation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9730884" y="2300559"/>
                  <a:ext cx="174511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sease Survey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文本框 37"/>
                <p:cNvSpPr txBox="1"/>
                <p:nvPr/>
              </p:nvSpPr>
              <p:spPr>
                <a:xfrm>
                  <a:off x="894352" y="1348533"/>
                  <a:ext cx="21603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th day Before TR4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9" name="直接连接符 38"/>
                <p:cNvCxnSpPr/>
                <p:nvPr/>
              </p:nvCxnSpPr>
              <p:spPr>
                <a:xfrm>
                  <a:off x="1065456" y="1710489"/>
                  <a:ext cx="0" cy="173255"/>
                </a:xfrm>
                <a:prstGeom prst="line">
                  <a:avLst/>
                </a:prstGeom>
                <a:ln w="508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接连接符 39"/>
                <p:cNvCxnSpPr/>
                <p:nvPr/>
              </p:nvCxnSpPr>
              <p:spPr>
                <a:xfrm>
                  <a:off x="5398170" y="1710490"/>
                  <a:ext cx="0" cy="173255"/>
                </a:xfrm>
                <a:prstGeom prst="line">
                  <a:avLst/>
                </a:prstGeom>
                <a:ln w="508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接连接符 40"/>
                <p:cNvCxnSpPr/>
                <p:nvPr/>
              </p:nvCxnSpPr>
              <p:spPr>
                <a:xfrm>
                  <a:off x="11155680" y="1710491"/>
                  <a:ext cx="0" cy="173255"/>
                </a:xfrm>
                <a:prstGeom prst="line">
                  <a:avLst/>
                </a:prstGeom>
                <a:ln w="508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文本框 41"/>
                <p:cNvSpPr txBox="1"/>
                <p:nvPr/>
              </p:nvSpPr>
              <p:spPr>
                <a:xfrm>
                  <a:off x="5027599" y="1348533"/>
                  <a:ext cx="74114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 dpi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10501163" y="1287267"/>
                  <a:ext cx="81894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2 dpi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" name="组合 80"/>
              <p:cNvGrpSpPr/>
              <p:nvPr/>
            </p:nvGrpSpPr>
            <p:grpSpPr>
              <a:xfrm>
                <a:off x="3054683" y="2121585"/>
                <a:ext cx="8421318" cy="741636"/>
                <a:chOff x="3054683" y="2121585"/>
                <a:chExt cx="8421318" cy="741636"/>
              </a:xfrm>
            </p:grpSpPr>
            <p:cxnSp>
              <p:nvCxnSpPr>
                <p:cNvPr id="47" name="直接箭头连接符 46"/>
                <p:cNvCxnSpPr/>
                <p:nvPr/>
              </p:nvCxnSpPr>
              <p:spPr>
                <a:xfrm flipV="1">
                  <a:off x="5398169" y="2229371"/>
                  <a:ext cx="0" cy="288758"/>
                </a:xfrm>
                <a:prstGeom prst="straightConnector1">
                  <a:avLst/>
                </a:prstGeom>
                <a:ln w="508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" name="组合 58"/>
                <p:cNvGrpSpPr/>
                <p:nvPr/>
              </p:nvGrpSpPr>
              <p:grpSpPr>
                <a:xfrm>
                  <a:off x="3054683" y="2121585"/>
                  <a:ext cx="8421318" cy="741636"/>
                  <a:chOff x="3054683" y="3507660"/>
                  <a:chExt cx="8421318" cy="741636"/>
                </a:xfrm>
              </p:grpSpPr>
              <p:cxnSp>
                <p:nvCxnSpPr>
                  <p:cNvPr id="44" name="直接连接符 43"/>
                  <p:cNvCxnSpPr/>
                  <p:nvPr/>
                </p:nvCxnSpPr>
                <p:spPr>
                  <a:xfrm>
                    <a:off x="3936734" y="3507660"/>
                    <a:ext cx="1482290" cy="0"/>
                  </a:xfrm>
                  <a:prstGeom prst="line">
                    <a:avLst/>
                  </a:prstGeom>
                  <a:ln w="203200">
                    <a:solidFill>
                      <a:schemeClr val="accent2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直接连接符 44"/>
                  <p:cNvCxnSpPr/>
                  <p:nvPr/>
                </p:nvCxnSpPr>
                <p:spPr>
                  <a:xfrm>
                    <a:off x="5419024" y="3507660"/>
                    <a:ext cx="5736656" cy="0"/>
                  </a:xfrm>
                  <a:prstGeom prst="line">
                    <a:avLst/>
                  </a:prstGeom>
                  <a:ln w="203200">
                    <a:solidFill>
                      <a:schemeClr val="accent4">
                        <a:lumMod val="60000"/>
                        <a:lumOff val="4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直接箭头连接符 45"/>
                  <p:cNvCxnSpPr/>
                  <p:nvPr/>
                </p:nvCxnSpPr>
                <p:spPr>
                  <a:xfrm flipV="1">
                    <a:off x="3936734" y="3615446"/>
                    <a:ext cx="0" cy="288758"/>
                  </a:xfrm>
                  <a:prstGeom prst="straightConnector1">
                    <a:avLst/>
                  </a:prstGeom>
                  <a:ln w="5080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直接箭头连接符 47"/>
                  <p:cNvCxnSpPr/>
                  <p:nvPr/>
                </p:nvCxnSpPr>
                <p:spPr>
                  <a:xfrm flipV="1">
                    <a:off x="11155680" y="3615446"/>
                    <a:ext cx="0" cy="288758"/>
                  </a:xfrm>
                  <a:prstGeom prst="straightConnector1">
                    <a:avLst/>
                  </a:prstGeom>
                  <a:ln w="5080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9" name="文本框 48"/>
                  <p:cNvSpPr txBox="1"/>
                  <p:nvPr/>
                </p:nvSpPr>
                <p:spPr>
                  <a:xfrm>
                    <a:off x="3054683" y="3879964"/>
                    <a:ext cx="174511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R4 Inoculation</a:t>
                    </a:r>
                    <a:endParaRPr lang="zh-CN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文本框 49"/>
                  <p:cNvSpPr txBox="1"/>
                  <p:nvPr/>
                </p:nvSpPr>
                <p:spPr>
                  <a:xfrm>
                    <a:off x="4890680" y="3868789"/>
                    <a:ext cx="158234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e Treatments</a:t>
                    </a:r>
                    <a:endParaRPr lang="zh-CN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文本框 50"/>
                  <p:cNvSpPr txBox="1"/>
                  <p:nvPr/>
                </p:nvSpPr>
                <p:spPr>
                  <a:xfrm>
                    <a:off x="9730884" y="3827323"/>
                    <a:ext cx="174511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isease Survey</a:t>
                    </a:r>
                    <a:endParaRPr lang="zh-CN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82" name="文本框 81"/>
              <p:cNvSpPr txBox="1"/>
              <p:nvPr/>
            </p:nvSpPr>
            <p:spPr>
              <a:xfrm>
                <a:off x="580512" y="473052"/>
                <a:ext cx="40292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" name="组合 83"/>
              <p:cNvGrpSpPr/>
              <p:nvPr/>
            </p:nvGrpSpPr>
            <p:grpSpPr>
              <a:xfrm>
                <a:off x="585720" y="2889971"/>
                <a:ext cx="10816750" cy="1698542"/>
                <a:chOff x="585720" y="2889971"/>
                <a:chExt cx="10816750" cy="1698542"/>
              </a:xfrm>
            </p:grpSpPr>
            <p:sp>
              <p:nvSpPr>
                <p:cNvPr id="62" name="箭头: 右 61"/>
                <p:cNvSpPr/>
                <p:nvPr/>
              </p:nvSpPr>
              <p:spPr>
                <a:xfrm>
                  <a:off x="1066307" y="3271526"/>
                  <a:ext cx="10090224" cy="591320"/>
                </a:xfrm>
                <a:prstGeom prst="rightArrow">
                  <a:avLst/>
                </a:prstGeom>
                <a:solidFill>
                  <a:schemeClr val="accent6">
                    <a:lumMod val="75000"/>
                  </a:schemeClr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3" name="流程图: 接点 62"/>
                <p:cNvSpPr/>
                <p:nvPr/>
              </p:nvSpPr>
              <p:spPr>
                <a:xfrm>
                  <a:off x="1066307" y="3417994"/>
                  <a:ext cx="272456" cy="298383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6" name="流程图: 接点 65"/>
                <p:cNvSpPr/>
                <p:nvPr/>
              </p:nvSpPr>
              <p:spPr>
                <a:xfrm>
                  <a:off x="5374515" y="3408908"/>
                  <a:ext cx="272456" cy="298383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7" name="流程图: 接点 66"/>
                <p:cNvSpPr/>
                <p:nvPr/>
              </p:nvSpPr>
              <p:spPr>
                <a:xfrm>
                  <a:off x="10605341" y="3417994"/>
                  <a:ext cx="272456" cy="298383"/>
                </a:xfrm>
                <a:prstGeom prst="flowChartConnector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68" name="直接连接符 67"/>
                <p:cNvCxnSpPr/>
                <p:nvPr/>
              </p:nvCxnSpPr>
              <p:spPr>
                <a:xfrm>
                  <a:off x="1212160" y="3242650"/>
                  <a:ext cx="0" cy="173255"/>
                </a:xfrm>
                <a:prstGeom prst="line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接连接符 68"/>
                <p:cNvCxnSpPr/>
                <p:nvPr/>
              </p:nvCxnSpPr>
              <p:spPr>
                <a:xfrm>
                  <a:off x="5510743" y="3239441"/>
                  <a:ext cx="0" cy="173255"/>
                </a:xfrm>
                <a:prstGeom prst="line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直接连接符 69"/>
                <p:cNvCxnSpPr/>
                <p:nvPr/>
              </p:nvCxnSpPr>
              <p:spPr>
                <a:xfrm>
                  <a:off x="10747587" y="3239441"/>
                  <a:ext cx="0" cy="173255"/>
                </a:xfrm>
                <a:prstGeom prst="line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文本框 70"/>
                <p:cNvSpPr txBox="1"/>
                <p:nvPr/>
              </p:nvSpPr>
              <p:spPr>
                <a:xfrm>
                  <a:off x="893808" y="2921482"/>
                  <a:ext cx="85798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ch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文本框 71"/>
                <p:cNvSpPr txBox="1"/>
                <p:nvPr/>
              </p:nvSpPr>
              <p:spPr>
                <a:xfrm>
                  <a:off x="5081749" y="2889971"/>
                  <a:ext cx="85798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uly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文本框 72"/>
                <p:cNvSpPr txBox="1"/>
                <p:nvPr/>
              </p:nvSpPr>
              <p:spPr>
                <a:xfrm>
                  <a:off x="10014597" y="2908306"/>
                  <a:ext cx="119873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cember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4" name="直接箭头连接符 73"/>
                <p:cNvCxnSpPr/>
                <p:nvPr/>
              </p:nvCxnSpPr>
              <p:spPr>
                <a:xfrm flipV="1">
                  <a:off x="5510743" y="3728670"/>
                  <a:ext cx="0" cy="288758"/>
                </a:xfrm>
                <a:prstGeom prst="straightConnector1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文本框 74"/>
                <p:cNvSpPr txBox="1"/>
                <p:nvPr/>
              </p:nvSpPr>
              <p:spPr>
                <a:xfrm>
                  <a:off x="4890680" y="3942182"/>
                  <a:ext cx="15823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e Treatments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文本框 75"/>
                <p:cNvSpPr txBox="1"/>
                <p:nvPr/>
              </p:nvSpPr>
              <p:spPr>
                <a:xfrm>
                  <a:off x="9375857" y="3942182"/>
                  <a:ext cx="2026613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sease Survey </a:t>
                  </a:r>
                </a:p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amples Collection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7" name="直接箭头连接符 76"/>
                <p:cNvCxnSpPr/>
                <p:nvPr/>
              </p:nvCxnSpPr>
              <p:spPr>
                <a:xfrm flipV="1">
                  <a:off x="1199197" y="3733576"/>
                  <a:ext cx="0" cy="288758"/>
                </a:xfrm>
                <a:prstGeom prst="straightConnector1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箭头连接符 77"/>
                <p:cNvCxnSpPr/>
                <p:nvPr/>
              </p:nvCxnSpPr>
              <p:spPr>
                <a:xfrm flipV="1">
                  <a:off x="10745854" y="3731972"/>
                  <a:ext cx="0" cy="288758"/>
                </a:xfrm>
                <a:prstGeom prst="straightConnector1">
                  <a:avLst/>
                </a:prstGeom>
                <a:ln w="50800">
                  <a:solidFill>
                    <a:schemeClr val="tx1">
                      <a:lumMod val="65000"/>
                      <a:lumOff val="3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文本框 78"/>
                <p:cNvSpPr txBox="1"/>
                <p:nvPr/>
              </p:nvSpPr>
              <p:spPr>
                <a:xfrm>
                  <a:off x="922684" y="3970132"/>
                  <a:ext cx="18117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nting Plantlets</a:t>
                  </a:r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>
                  <a:off x="585720" y="3372485"/>
                  <a:ext cx="402920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86" name="文本框 85"/>
            <p:cNvSpPr txBox="1"/>
            <p:nvPr/>
          </p:nvSpPr>
          <p:spPr>
            <a:xfrm>
              <a:off x="623392" y="942836"/>
              <a:ext cx="51179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623392" y="1951207"/>
              <a:ext cx="54019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666712" y="4437112"/>
            <a:ext cx="10715699" cy="2272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The comprehensive design scheme of sample by artificial inoculation in greenhouse (A) and by natural infection in field (B).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150000"/>
              </a:lnSpc>
            </a:pP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:</a:t>
            </a:r>
          </a:p>
          <a:p>
            <a:pPr>
              <a:lnSpc>
                <a:spcPct val="150000"/>
              </a:lnSpc>
            </a:pP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) The different concentrations of Se treatments for 14 days before </a:t>
            </a:r>
            <a:r>
              <a:rPr lang="en-US" altLang="zh-CN" sz="105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R4 inoculation, encompassed 1, 5, 10, 20, 40, 80, and 160 mg/L of  Se solution. Treatments were labeled as Se01, Se05, Se10, Se20, Se40, Se80, and Se160. </a:t>
            </a:r>
          </a:p>
          <a:p>
            <a:pPr>
              <a:lnSpc>
                <a:spcPct val="150000"/>
              </a:lnSpc>
            </a:pP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Inoculating banana plants with </a:t>
            </a:r>
            <a:r>
              <a:rPr lang="en-US" altLang="zh-CN" sz="105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altLang="zh-CN" sz="105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4 at 7 dpi and irrigate with Se solutions at final concentrations of  20, 40, 80, and 160 mg/L. Because the final concentrations of  Se treated first  in Figure S1A(b) were greater than or equal to 20 mg/L, which has a significantly control effect on </a:t>
            </a:r>
            <a:r>
              <a:rPr lang="en-US" altLang="zh-CN" sz="105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c</a:t>
            </a:r>
            <a:r>
              <a:rPr lang="en-US" altLang="zh-CN" sz="105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4, only these four concentration treatments were selected in this section. Treatments were labeled as Se20B, Se40B, Se80B, and Se160B. </a:t>
            </a:r>
          </a:p>
          <a:p>
            <a:pPr>
              <a:lnSpc>
                <a:spcPct val="150000"/>
              </a:lnSpc>
            </a:pPr>
            <a:r>
              <a:rPr lang="en-US" altLang="zh-CN" sz="105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 The two concentrations of  Se solution with water (40 mg/L and 80 mg/L) were prepared. And 2.5 L of Se solution for drenching near corm, labeled as Se100, Se200.</a:t>
            </a:r>
          </a:p>
          <a:p>
            <a:pPr>
              <a:lnSpc>
                <a:spcPct val="150000"/>
              </a:lnSpc>
            </a:pP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200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61</Words>
  <Application>Microsoft Office PowerPoint</Application>
  <PresentationFormat>Widescreen</PresentationFormat>
  <Paragraphs>3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ln</dc:creator>
  <cp:lastModifiedBy>MDPI</cp:lastModifiedBy>
  <cp:revision>405</cp:revision>
  <dcterms:created xsi:type="dcterms:W3CDTF">2022-03-12T09:17:00Z</dcterms:created>
  <dcterms:modified xsi:type="dcterms:W3CDTF">2024-12-06T16:25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